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73" autoAdjust="0"/>
  </p:normalViewPr>
  <p:slideViewPr>
    <p:cSldViewPr snapToGrid="0">
      <p:cViewPr varScale="1">
        <p:scale>
          <a:sx n="81" d="100"/>
          <a:sy n="81" d="100"/>
        </p:scale>
        <p:origin x="33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임승혁" userId="50080d77-0d6e-4880-96a7-58e4dd6aba5c" providerId="ADAL" clId="{6AF203D3-77E0-466B-A9E3-CE7607ADD6C1}"/>
    <pc:docChg chg="undo custSel modSld">
      <pc:chgData name="임승혁" userId="50080d77-0d6e-4880-96a7-58e4dd6aba5c" providerId="ADAL" clId="{6AF203D3-77E0-466B-A9E3-CE7607ADD6C1}" dt="2023-05-09T01:57:12.658" v="256" actId="14100"/>
      <pc:docMkLst>
        <pc:docMk/>
      </pc:docMkLst>
      <pc:sldChg chg="modSp mod">
        <pc:chgData name="임승혁" userId="50080d77-0d6e-4880-96a7-58e4dd6aba5c" providerId="ADAL" clId="{6AF203D3-77E0-466B-A9E3-CE7607ADD6C1}" dt="2023-05-09T01:57:12.658" v="256" actId="14100"/>
        <pc:sldMkLst>
          <pc:docMk/>
          <pc:sldMk cId="3431822228" sldId="256"/>
        </pc:sldMkLst>
        <pc:spChg chg="mod">
          <ac:chgData name="임승혁" userId="50080d77-0d6e-4880-96a7-58e4dd6aba5c" providerId="ADAL" clId="{6AF203D3-77E0-466B-A9E3-CE7607ADD6C1}" dt="2023-05-09T01:55:23.318" v="11" actId="1035"/>
          <ac:spMkLst>
            <pc:docMk/>
            <pc:sldMk cId="3431822228" sldId="256"/>
            <ac:spMk id="5" creationId="{A2B06BF4-8BA6-EA6E-3403-93919840A4E6}"/>
          </ac:spMkLst>
        </pc:spChg>
        <pc:spChg chg="mod">
          <ac:chgData name="임승혁" userId="50080d77-0d6e-4880-96a7-58e4dd6aba5c" providerId="ADAL" clId="{6AF203D3-77E0-466B-A9E3-CE7607ADD6C1}" dt="2023-05-09T01:57:08.755" v="255" actId="1036"/>
          <ac:spMkLst>
            <pc:docMk/>
            <pc:sldMk cId="3431822228" sldId="256"/>
            <ac:spMk id="6" creationId="{BF25BFE9-B681-C1BE-A27A-ABB17CCE3961}"/>
          </ac:spMkLst>
        </pc:spChg>
        <pc:picChg chg="mod modCrop">
          <ac:chgData name="임승혁" userId="50080d77-0d6e-4880-96a7-58e4dd6aba5c" providerId="ADAL" clId="{6AF203D3-77E0-466B-A9E3-CE7607ADD6C1}" dt="2023-05-09T01:57:12.658" v="256" actId="14100"/>
          <ac:picMkLst>
            <pc:docMk/>
            <pc:sldMk cId="3431822228" sldId="256"/>
            <ac:picMk id="4" creationId="{5128FDE4-C49C-3003-319C-CA1C90D4F163}"/>
          </ac:picMkLst>
        </pc:picChg>
        <pc:cxnChg chg="mod">
          <ac:chgData name="임승혁" userId="50080d77-0d6e-4880-96a7-58e4dd6aba5c" providerId="ADAL" clId="{6AF203D3-77E0-466B-A9E3-CE7607ADD6C1}" dt="2023-05-09T01:57:08.755" v="255" actId="1036"/>
          <ac:cxnSpMkLst>
            <pc:docMk/>
            <pc:sldMk cId="3431822228" sldId="256"/>
            <ac:cxnSpMk id="8" creationId="{ACE8C632-8FAA-0062-92DC-0D02AE043F86}"/>
          </ac:cxnSpMkLst>
        </pc:cxnChg>
      </pc:sldChg>
    </pc:docChg>
  </pc:docChgLst>
  <pc:docChgLst>
    <pc:chgData name="임승혁" userId="50080d77-0d6e-4880-96a7-58e4dd6aba5c" providerId="ADAL" clId="{69CD9D5D-F755-4253-B2A1-B7BD266653AC}"/>
    <pc:docChg chg="modSld">
      <pc:chgData name="임승혁" userId="50080d77-0d6e-4880-96a7-58e4dd6aba5c" providerId="ADAL" clId="{69CD9D5D-F755-4253-B2A1-B7BD266653AC}" dt="2023-07-03T03:20:25.104" v="3" actId="6549"/>
      <pc:docMkLst>
        <pc:docMk/>
      </pc:docMkLst>
      <pc:sldChg chg="modSp mod">
        <pc:chgData name="임승혁" userId="50080d77-0d6e-4880-96a7-58e4dd6aba5c" providerId="ADAL" clId="{69CD9D5D-F755-4253-B2A1-B7BD266653AC}" dt="2023-07-03T03:20:25.104" v="3" actId="6549"/>
        <pc:sldMkLst>
          <pc:docMk/>
          <pc:sldMk cId="3431822228" sldId="256"/>
        </pc:sldMkLst>
        <pc:spChg chg="mod">
          <ac:chgData name="임승혁" userId="50080d77-0d6e-4880-96a7-58e4dd6aba5c" providerId="ADAL" clId="{69CD9D5D-F755-4253-B2A1-B7BD266653AC}" dt="2023-07-03T03:20:25.104" v="3" actId="6549"/>
          <ac:spMkLst>
            <pc:docMk/>
            <pc:sldMk cId="3431822228" sldId="256"/>
            <ac:spMk id="5" creationId="{A2B06BF4-8BA6-EA6E-3403-93919840A4E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A8ACC-800C-411D-A947-8DB322DD5BD6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5FC58-540C-479B-B142-3AE2D6087C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4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5FC58-540C-479B-B142-3AE2D6087CD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976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91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3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2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16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31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4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34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178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17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38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9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33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128FDE4-C49C-3003-319C-CA1C90D4F1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37" r="-184"/>
          <a:stretch/>
        </p:blipFill>
        <p:spPr bwMode="auto">
          <a:xfrm>
            <a:off x="669589" y="904125"/>
            <a:ext cx="7582916" cy="544917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B06BF4-8BA6-EA6E-3403-93919840A4E6}"/>
              </a:ext>
            </a:extLst>
          </p:cNvPr>
          <p:cNvSpPr txBox="1"/>
          <p:nvPr/>
        </p:nvSpPr>
        <p:spPr>
          <a:xfrm>
            <a:off x="134936" y="33637"/>
            <a:ext cx="8753273" cy="8728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l Digital </a:t>
            </a:r>
            <a:r>
              <a:rPr lang="en-US" altLang="ko-KR" sz="1800" b="1" kern="10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ntent 9. </a:t>
            </a: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bsolute standardized differences in un-weighted and weighted covariates of baseline characteristics on waitlisting day.</a:t>
            </a:r>
            <a:endParaRPr lang="ko-KR" altLang="ko-KR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25BFE9-B681-C1BE-A27A-ABB17CCE3961}"/>
              </a:ext>
            </a:extLst>
          </p:cNvPr>
          <p:cNvSpPr txBox="1"/>
          <p:nvPr/>
        </p:nvSpPr>
        <p:spPr>
          <a:xfrm>
            <a:off x="134936" y="6496197"/>
            <a:ext cx="8753273" cy="5730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MELD,</a:t>
            </a:r>
            <a:r>
              <a:rPr lang="ko-KR" altLang="en-US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1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Medel</a:t>
            </a:r>
            <a:r>
              <a:rPr lang="ko-KR" altLang="en-US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for</a:t>
            </a:r>
            <a:r>
              <a:rPr lang="ko-KR" altLang="en-US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End-stage Liver Disease; ACLF, acute-on-chronic liver failure; ALF, acute liver failure; </a:t>
            </a:r>
            <a:r>
              <a:rPr lang="en-US" altLang="ko-KR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ICU, intensive care unit; HCC, hepatocellular carcinoma</a:t>
            </a:r>
            <a:endParaRPr lang="ko-KR" altLang="ko-KR" sz="105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ACE8C632-8FAA-0062-92DC-0D02AE043F86}"/>
              </a:ext>
            </a:extLst>
          </p:cNvPr>
          <p:cNvCxnSpPr>
            <a:cxnSpLocks/>
          </p:cNvCxnSpPr>
          <p:nvPr/>
        </p:nvCxnSpPr>
        <p:spPr>
          <a:xfrm>
            <a:off x="134936" y="6519947"/>
            <a:ext cx="8495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18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</TotalTime>
  <Words>51</Words>
  <Application>Microsoft Office PowerPoint</Application>
  <PresentationFormat>사용자 지정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im Seung Hyuk</dc:creator>
  <cp:lastModifiedBy>임승혁</cp:lastModifiedBy>
  <cp:revision>3</cp:revision>
  <dcterms:created xsi:type="dcterms:W3CDTF">2023-05-09T01:23:50Z</dcterms:created>
  <dcterms:modified xsi:type="dcterms:W3CDTF">2023-07-03T03:20:26Z</dcterms:modified>
</cp:coreProperties>
</file>